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6858000" cy="90043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42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73621"/>
            <a:ext cx="5829300" cy="313483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729343"/>
            <a:ext cx="5143500" cy="217395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4830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2314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79396"/>
            <a:ext cx="1478756" cy="76307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79396"/>
            <a:ext cx="4350544" cy="76307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2953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6715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44825"/>
            <a:ext cx="5915025" cy="3745538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025797"/>
            <a:ext cx="5915025" cy="196969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6392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96978"/>
            <a:ext cx="2914650" cy="571314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96978"/>
            <a:ext cx="2914650" cy="571314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2289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398"/>
            <a:ext cx="5915025" cy="174041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07305"/>
            <a:ext cx="2901255" cy="108176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289070"/>
            <a:ext cx="2901255" cy="483772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07305"/>
            <a:ext cx="2915543" cy="108176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289070"/>
            <a:ext cx="2915543" cy="483772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9902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1218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3878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0287"/>
            <a:ext cx="2211884" cy="2101003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96454"/>
            <a:ext cx="3471863" cy="639888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01290"/>
            <a:ext cx="2211884" cy="500447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3011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0287"/>
            <a:ext cx="2211884" cy="2101003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96454"/>
            <a:ext cx="3471863" cy="639888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01290"/>
            <a:ext cx="2211884" cy="500447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617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79398"/>
            <a:ext cx="5915025" cy="1740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96978"/>
            <a:ext cx="5915025" cy="571314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345654"/>
            <a:ext cx="1543050" cy="4793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345654"/>
            <a:ext cx="2314575" cy="4793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345654"/>
            <a:ext cx="1543050" cy="4793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4310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911620"/>
              </p:ext>
            </p:extLst>
          </p:nvPr>
        </p:nvGraphicFramePr>
        <p:xfrm>
          <a:off x="366081" y="1488871"/>
          <a:ext cx="6125839" cy="7277718"/>
        </p:xfrm>
        <a:graphic>
          <a:graphicData uri="http://schemas.openxmlformats.org/drawingml/2006/table">
            <a:tbl>
              <a:tblPr firstRow="1" firstCol="1" bandRow="1"/>
              <a:tblGrid>
                <a:gridCol w="128406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5224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20934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43861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241577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</a:tblGrid>
              <a:tr h="285678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ype of fracture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 patient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umber (%) of patients with 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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fracture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umber of fracture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88040">
                <a:tc>
                  <a:txBody>
                    <a:bodyPr/>
                    <a:lstStyle/>
                    <a:p>
                      <a:pPr marL="93345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ime interval (months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er given interval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er 10,000 patient-years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42839">
                <a:tc gridSpan="5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Hip fracture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‒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3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 (0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6‒1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5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 (0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12‒1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84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0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18‒2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0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 (0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4‒3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0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30‒3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4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 (0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36‒4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4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0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42839">
                <a:tc gridSpan="5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Humerus fracture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‒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3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6‒1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5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 (0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12‒1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8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0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18‒2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0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 (0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4‒3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 (0.3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30‒3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4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0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36‒4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0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142839">
                <a:tc gridSpan="5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eg fracture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‒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3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0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6‒1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5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0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12‒1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8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0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18‒2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0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 (0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4‒3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0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30‒3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4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0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36‒4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142839">
                <a:tc gridSpan="5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orearm/wrist fracture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‒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3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 (1.0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7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6‒1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5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 (0.5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8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12‒1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8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 (0.5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9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18‒2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0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 (0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0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4‒3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 (0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1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30‒3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4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 (0.8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2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36‒4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0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3"/>
                  </a:ext>
                </a:extLst>
              </a:tr>
              <a:tr h="142839">
                <a:tc gridSpan="5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ernum/ribs fracture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34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‒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3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0.1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5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6‒1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5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 (0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6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12‒1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8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7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18‒2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0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 (0.4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8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4‒3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 (0.3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9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9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30‒3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4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0.2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40"/>
                  </a:ext>
                </a:extLst>
              </a:tr>
              <a:tr h="142839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36‒4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9333" marR="593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41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59758" y="1207139"/>
            <a:ext cx="6125837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GB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line Resource 1. </a:t>
            </a:r>
            <a:r>
              <a:rPr lang="en-GB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cidence of main non-vertebral fractures by location (Total Study Cohort)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D99037AE-B8BA-47C0-A2A1-83163EA449DE}"/>
              </a:ext>
            </a:extLst>
          </p:cNvPr>
          <p:cNvSpPr txBox="1"/>
          <p:nvPr/>
        </p:nvSpPr>
        <p:spPr>
          <a:xfrm>
            <a:off x="259758" y="211454"/>
            <a:ext cx="6338487" cy="923330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Effectiveness of teriparatide in patients with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osteoporosis in clinical practice: 42-month results during and after discontinuation of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treatment from the European Extended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Forsteo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Observational Study (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ExFOS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Calcified Tissue International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N. Napoli, B. L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Langdahl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Ö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Ljunggren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E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Lespessaille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G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apetano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T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ocjan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T. Nikolic, P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Eiken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H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etto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T. Moll, E. Lindh, F. Marin</a:t>
            </a:r>
          </a:p>
          <a:p>
            <a:pPr>
              <a:defRPr/>
            </a:pPr>
            <a:r>
              <a:rPr lang="en-GB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responding author: Nicola Napoli,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niversity Campus Bio-Medico, Rome, Italy; e-mail: </a:t>
            </a:r>
            <a:r>
              <a:rPr lang="en-GB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.Napoli@unicampus.it</a:t>
            </a:r>
          </a:p>
        </p:txBody>
      </p:sp>
    </p:spTree>
    <p:extLst>
      <p:ext uri="{BB962C8B-B14F-4D97-AF65-F5344CB8AC3E}">
        <p14:creationId xmlns:p14="http://schemas.microsoft.com/office/powerpoint/2010/main" val="3635287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450</Words>
  <Application>Microsoft Office PowerPoint</Application>
  <PresentationFormat>Custom</PresentationFormat>
  <Paragraphs>19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x</dc:creator>
  <cp:lastModifiedBy>Rx</cp:lastModifiedBy>
  <cp:revision>7</cp:revision>
  <dcterms:created xsi:type="dcterms:W3CDTF">2017-07-05T13:17:28Z</dcterms:created>
  <dcterms:modified xsi:type="dcterms:W3CDTF">2018-01-18T14:14:32Z</dcterms:modified>
</cp:coreProperties>
</file>